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B8D78E-358B-43F4-817E-6F3E0FBCEDE5}" type="datetimeFigureOut">
              <a:rPr lang="en-GB" smtClean="0"/>
              <a:t>16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FD91A-4961-4F86-ABE0-9CC1A540B7F4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6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8696295"/>
              </p:ext>
            </p:extLst>
          </p:nvPr>
        </p:nvGraphicFramePr>
        <p:xfrm>
          <a:off x="107950" y="-171400"/>
          <a:ext cx="8928100" cy="6389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5" r:id="rId3" imgW="8927640" imgH="6390000" progId="Prism5.Document">
                  <p:embed/>
                </p:oleObj>
              </mc:Choice>
              <mc:Fallback>
                <p:oleObj name="Prism 5" r:id="rId3" imgW="8927640" imgH="6390000" progId="Prism5.Document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950" y="-171400"/>
                        <a:ext cx="8928100" cy="63896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79512" y="6021288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3. Linear regression analysis of </a:t>
            </a:r>
            <a:r>
              <a:rPr lang="en-GB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sulfite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NGS data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near regression was performed (A) without constraining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,y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tercept (as Figur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or (B) setting the intercept as (0,0). Residuals of the regression for each method are plotted in (C) and (D) respectively. A runs test for non-linearit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av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values of 0.11 an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007 for (C) and (D) respectively indicating that regression (B) is significantly non-linear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7504" y="11663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7504" y="313167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860032" y="11663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932040" y="313167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9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lison Devonshire</dc:creator>
  <cp:lastModifiedBy>nicholas.redsha</cp:lastModifiedBy>
  <cp:revision>13</cp:revision>
  <cp:lastPrinted>2014-03-18T10:12:11Z</cp:lastPrinted>
  <dcterms:created xsi:type="dcterms:W3CDTF">2014-02-28T12:00:25Z</dcterms:created>
  <dcterms:modified xsi:type="dcterms:W3CDTF">2014-12-16T12:34:53Z</dcterms:modified>
</cp:coreProperties>
</file>